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0" d="100"/>
          <a:sy n="80" d="100"/>
        </p:scale>
        <p:origin x="3006" y="-7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5444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8417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4679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0848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2498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5929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6633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5606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50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1446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3354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335DD1-4EBB-4FF0-9C6F-D153157F4DA2}" type="datetimeFigureOut">
              <a:rPr lang="de-DE" smtClean="0"/>
              <a:t>03.11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30FEF0-F158-4DF7-B376-16F562413EA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2474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306453E6-7815-D451-8A4E-F902C635AD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86393"/>
            <a:ext cx="6858000" cy="786261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04D5E9D8-53AC-AAB2-9DDB-3259ECE44755}"/>
              </a:ext>
            </a:extLst>
          </p:cNvPr>
          <p:cNvSpPr txBox="1"/>
          <p:nvPr/>
        </p:nvSpPr>
        <p:spPr>
          <a:xfrm>
            <a:off x="0" y="9288379"/>
            <a:ext cx="671362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1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eutrophil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osinophil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onchoalveolar lavage at pre-challenge baseline and following LPS or saline challenge for placebo-treated participants. Data are given as dot plots with median and interquartile range. Analysis of variance (ANOVA) followed by Tukey post hoc test was used for statistical comparison. ****p&lt;0.0001, LPS = lipopolysaccharide, ns = not significant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9195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91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ress, Christina</dc:creator>
  <cp:lastModifiedBy>Gress, Christina</cp:lastModifiedBy>
  <cp:revision>2</cp:revision>
  <dcterms:created xsi:type="dcterms:W3CDTF">2023-11-03T10:15:45Z</dcterms:created>
  <dcterms:modified xsi:type="dcterms:W3CDTF">2023-11-03T10:31:07Z</dcterms:modified>
</cp:coreProperties>
</file>